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40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20"/>
    <p:restoredTop sz="94665"/>
  </p:normalViewPr>
  <p:slideViewPr>
    <p:cSldViewPr snapToGrid="0" snapToObjects="1" showGuides="1">
      <p:cViewPr varScale="1">
        <p:scale>
          <a:sx n="89" d="100"/>
          <a:sy n="89" d="100"/>
        </p:scale>
        <p:origin x="3528" y="184"/>
      </p:cViewPr>
      <p:guideLst>
        <p:guide orient="horz" pos="24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5840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9909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3477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9347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7353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1199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2725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4792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6855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3332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2355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01CA0B-4340-4543-A205-8EE7B0421103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8D446-1108-EB4D-8EAD-F99A768E098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4200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92B26D52-5C88-4A46-9E45-BD813AFDB5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8596" y="2275196"/>
            <a:ext cx="2160000" cy="1528732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84607BBD-2931-D042-94F3-042BD907B9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85835" y="3976608"/>
            <a:ext cx="2160000" cy="1486849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D40B278E-3D81-6D43-8373-99E64D8371E1}"/>
              </a:ext>
            </a:extLst>
          </p:cNvPr>
          <p:cNvSpPr txBox="1"/>
          <p:nvPr/>
        </p:nvSpPr>
        <p:spPr>
          <a:xfrm>
            <a:off x="2149943" y="218423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1632A58D-BFA7-4E48-A72C-C5F607C28C20}"/>
              </a:ext>
            </a:extLst>
          </p:cNvPr>
          <p:cNvSpPr txBox="1"/>
          <p:nvPr/>
        </p:nvSpPr>
        <p:spPr>
          <a:xfrm>
            <a:off x="2137453" y="38033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2B9FF24-4EE4-864F-BA92-91B730E0C3F7}"/>
              </a:ext>
            </a:extLst>
          </p:cNvPr>
          <p:cNvSpPr/>
          <p:nvPr/>
        </p:nvSpPr>
        <p:spPr>
          <a:xfrm>
            <a:off x="1714500" y="5463457"/>
            <a:ext cx="355758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6. BAFF-R and TACI expression in T</a:t>
            </a:r>
            <a:r>
              <a:rPr lang="en-GB" sz="1200" b="1" baseline="-25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H 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nd other mCD4 T-cell subsets.</a:t>
            </a:r>
            <a:endParaRPr lang="fr-FR" sz="1200" dirty="0">
              <a:latin typeface="Times New Roman" panose="020206030504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marL="55563" algn="just">
              <a:spcAft>
                <a:spcPts val="0"/>
              </a:spcAft>
            </a:pP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rface expression of BAFF-R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% of positive cells) and TACI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,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% of positive cells) were analysed in every mCD4 T-cell subset from 8 Placebos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white bar)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nd 5 Treated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hatched bar)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macaques. Results are presented in Box-and-whiskers (5-95 percentile) plots with horizontal bars indicating Median values. Statistical comparisons between groups were carried out using two-way ANOVA with Bonferroni’s multiple comparisons test. Significant statistical values are indicated 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*p&lt;0.05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</a:t>
            </a:r>
            <a:endParaRPr lang="fr-FR" sz="1200" dirty="0">
              <a:latin typeface="Times New Roman" panose="020206030504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36709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06</Words>
  <Application>Microsoft Macintosh PowerPoint</Application>
  <PresentationFormat>Format A4 (210 x 297 mm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Yolande RICHARD</cp:lastModifiedBy>
  <cp:revision>3</cp:revision>
  <dcterms:created xsi:type="dcterms:W3CDTF">2020-01-16T19:06:05Z</dcterms:created>
  <dcterms:modified xsi:type="dcterms:W3CDTF">2020-01-27T09:58:32Z</dcterms:modified>
</cp:coreProperties>
</file>